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0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Estilo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779" autoAdjust="0"/>
    <p:restoredTop sz="92941" autoAdjust="0"/>
  </p:normalViewPr>
  <p:slideViewPr>
    <p:cSldViewPr>
      <p:cViewPr varScale="1">
        <p:scale>
          <a:sx n="106" d="100"/>
          <a:sy n="106" d="100"/>
        </p:scale>
        <p:origin x="2100" y="102"/>
      </p:cViewPr>
      <p:guideLst>
        <p:guide orient="horz" pos="2160"/>
        <p:guide pos="2880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8B3ED-EF14-49AC-8ECE-5D8EE42BFDBA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FC69F-847F-4C1D-B830-81A4D0F3D85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665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535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3774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3201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4737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6751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3108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134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8212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271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4002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2334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150AFF-8CA1-4507-82C1-5186032793E7}" type="datetimeFigureOut">
              <a:rPr lang="es-ES" smtClean="0"/>
              <a:t>28/1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6D660-FE44-406C-B7E0-D2E3A2EDC9A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0062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id="{B2A77477-D628-7C65-5EC8-309AB828B0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3036555"/>
              </p:ext>
            </p:extLst>
          </p:nvPr>
        </p:nvGraphicFramePr>
        <p:xfrm>
          <a:off x="462373" y="692696"/>
          <a:ext cx="8219253" cy="1993511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383361">
                  <a:extLst>
                    <a:ext uri="{9D8B030D-6E8A-4147-A177-3AD203B41FA5}">
                      <a16:colId xmlns:a16="http://schemas.microsoft.com/office/drawing/2014/main" val="1646217886"/>
                    </a:ext>
                  </a:extLst>
                </a:gridCol>
                <a:gridCol w="475368">
                  <a:extLst>
                    <a:ext uri="{9D8B030D-6E8A-4147-A177-3AD203B41FA5}">
                      <a16:colId xmlns:a16="http://schemas.microsoft.com/office/drawing/2014/main" val="3774239761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1575616117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3499311156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1279575688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3774962386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2150350286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3153885900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226155468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1092642389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3280161151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594687436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1642885176"/>
                    </a:ext>
                  </a:extLst>
                </a:gridCol>
                <a:gridCol w="613377">
                  <a:extLst>
                    <a:ext uri="{9D8B030D-6E8A-4147-A177-3AD203B41FA5}">
                      <a16:colId xmlns:a16="http://schemas.microsoft.com/office/drawing/2014/main" val="2331885748"/>
                    </a:ext>
                  </a:extLst>
                </a:gridCol>
              </a:tblGrid>
              <a:tr h="153347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Serie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 Case 1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 Case 2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 Case 3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 Case 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 Case 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 Case 6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 Case 7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 Case 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 Case 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Average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Max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Min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406207906"/>
                  </a:ext>
                </a:extLst>
              </a:tr>
              <a:tr h="153347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s-ES" sz="900" u="none" strike="noStrike" dirty="0" err="1">
                          <a:effectLst/>
                        </a:rPr>
                        <a:t>Length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LI-A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.8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.7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.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2.9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,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.1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.2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.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.1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.3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2.9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.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132622537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LI-LV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4.1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5.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3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5.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26345493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LI-LGN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5.1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8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4.82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3.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3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5.1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271034001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LI-Pul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5.7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7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4.5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8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7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4.3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.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5.7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12528012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LI-Fx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4.3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1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7.2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1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01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7.2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.19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130374824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A-LV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3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7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3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3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1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3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137528505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LV-LGN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9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5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9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6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4.2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7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3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4.2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162844999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LGN-Pul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6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2.7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2.9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2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1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6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2.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9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.26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681771209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Pul-Fx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7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7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9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2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7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74003277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A-Fx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4.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1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4.3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9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8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4.3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.89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034162878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LGN-Fx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7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44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.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2.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1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7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.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591537679"/>
                  </a:ext>
                </a:extLst>
              </a:tr>
              <a:tr h="1533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LV-Fx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1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2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7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4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19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.6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.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0.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.7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3.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0.19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67" marR="7667" marT="7667" marB="0" anchor="b">
                    <a:lnL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795139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3946249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17</TotalTime>
  <Words>188</Words>
  <Application>Microsoft Office PowerPoint</Application>
  <PresentationFormat>Presentación en pantalla (4:3)</PresentationFormat>
  <Paragraphs>17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Company>Universidad de Castilla-La Manc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aquin</dc:creator>
  <cp:lastModifiedBy>Joaquín González Fuentes</cp:lastModifiedBy>
  <cp:revision>309</cp:revision>
  <dcterms:created xsi:type="dcterms:W3CDTF">2013-07-09T16:36:41Z</dcterms:created>
  <dcterms:modified xsi:type="dcterms:W3CDTF">2022-11-28T07:15:47Z</dcterms:modified>
</cp:coreProperties>
</file>